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B9E7B6-A046-4EDE-BD59-D3119D9CC89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AC8CA2-CB09-4762-80AC-DD73D245BF8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D9E18F-4247-485D-B7B6-2BBBD44865FD}" type="slidenum"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7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347E4-D765-490B-A42D-F4B2387189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1F08F9-33BF-4089-9395-F1C9C5946F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694396-14B6-483E-B79D-44A5518A94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79C6C-D049-4730-A46F-ED6B0D28DE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55EA5-4F98-4A39-8052-7FD1AFC14C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C6C2B0-DD73-4CF2-9B15-24A25AF590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AC30FC-C94F-4051-A6D0-D4A03DF7E1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229079-6066-4E55-BC49-69269B7C1C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0C350-E569-4D23-A453-60F58363EA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42C025-CCE1-4EC9-875E-21BE4C33AF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EACD39-0F8F-4BDE-9C36-E01A08EDFB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E688D-1519-40F2-A8AB-FA41479842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55F283-95FA-465F-9D96-5971854F2C9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83"/>
          <p:cNvSpPr/>
          <p:nvPr/>
        </p:nvSpPr>
        <p:spPr>
          <a:xfrm>
            <a:off x="260280" y="468360"/>
            <a:ext cx="332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l Fig. 3 - Duncan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5"/>
          <p:cNvGrpSpPr/>
          <p:nvPr/>
        </p:nvGrpSpPr>
        <p:grpSpPr>
          <a:xfrm>
            <a:off x="4724640" y="2862360"/>
            <a:ext cx="381960" cy="3223800"/>
            <a:chOff x="4724640" y="2862360"/>
            <a:chExt cx="381960" cy="3223800"/>
          </a:xfrm>
        </p:grpSpPr>
        <p:sp>
          <p:nvSpPr>
            <p:cNvPr id="50" name="Rectangle 6"/>
            <p:cNvSpPr/>
            <p:nvPr/>
          </p:nvSpPr>
          <p:spPr>
            <a:xfrm flipH="1">
              <a:off x="4724640" y="5820480"/>
              <a:ext cx="379080" cy="26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2440" rIns="82440" tIns="41400" bIns="41400" anchor="t">
              <a:spAutoFit/>
            </a:bodyPr>
            <a:p>
              <a:pPr>
                <a:tabLst>
                  <a:tab algn="l" pos="0"/>
                  <a:tab algn="l" pos="739800"/>
                  <a:tab algn="l" pos="1479600"/>
                  <a:tab algn="l" pos="2219400"/>
                  <a:tab algn="l" pos="2959200"/>
                  <a:tab algn="l" pos="3699000"/>
                  <a:tab algn="l" pos="4438800"/>
                  <a:tab algn="l" pos="5178600"/>
                  <a:tab algn="l" pos="5918040"/>
                  <a:tab algn="l" pos="6657840"/>
                  <a:tab algn="l" pos="7397640"/>
                  <a:tab algn="l" pos="8137440"/>
                  <a:tab algn="l" pos="8877240"/>
                  <a:tab algn="l" pos="9617040"/>
                  <a:tab algn="l" pos="1035684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7"/>
            <p:cNvSpPr/>
            <p:nvPr/>
          </p:nvSpPr>
          <p:spPr>
            <a:xfrm flipH="1">
              <a:off x="4727160" y="4833720"/>
              <a:ext cx="379080" cy="26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2440" rIns="82440" tIns="41400" bIns="41400" anchor="t">
              <a:spAutoFit/>
            </a:bodyPr>
            <a:p>
              <a:pPr>
                <a:tabLst>
                  <a:tab algn="l" pos="0"/>
                  <a:tab algn="l" pos="739800"/>
                  <a:tab algn="l" pos="1479600"/>
                  <a:tab algn="l" pos="2219400"/>
                  <a:tab algn="l" pos="2959200"/>
                  <a:tab algn="l" pos="3699000"/>
                  <a:tab algn="l" pos="4438800"/>
                  <a:tab algn="l" pos="5178600"/>
                  <a:tab algn="l" pos="5918040"/>
                  <a:tab algn="l" pos="6657840"/>
                  <a:tab algn="l" pos="7397640"/>
                  <a:tab algn="l" pos="8137440"/>
                  <a:tab algn="l" pos="8877240"/>
                  <a:tab algn="l" pos="9617040"/>
                  <a:tab algn="l" pos="1035684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8"/>
            <p:cNvSpPr/>
            <p:nvPr/>
          </p:nvSpPr>
          <p:spPr>
            <a:xfrm flipH="1">
              <a:off x="4724640" y="3848040"/>
              <a:ext cx="379080" cy="26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2440" rIns="82440" tIns="41400" bIns="41400" anchor="t">
              <a:spAutoFit/>
            </a:bodyPr>
            <a:p>
              <a:pPr>
                <a:tabLst>
                  <a:tab algn="l" pos="0"/>
                  <a:tab algn="l" pos="739800"/>
                  <a:tab algn="l" pos="1479600"/>
                  <a:tab algn="l" pos="2219400"/>
                  <a:tab algn="l" pos="2959200"/>
                  <a:tab algn="l" pos="3699000"/>
                  <a:tab algn="l" pos="4438800"/>
                  <a:tab algn="l" pos="5178600"/>
                  <a:tab algn="l" pos="5918040"/>
                  <a:tab algn="l" pos="6657840"/>
                  <a:tab algn="l" pos="7397640"/>
                  <a:tab algn="l" pos="8137440"/>
                  <a:tab algn="l" pos="8877240"/>
                  <a:tab algn="l" pos="9617040"/>
                  <a:tab algn="l" pos="1035684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9"/>
            <p:cNvSpPr/>
            <p:nvPr/>
          </p:nvSpPr>
          <p:spPr>
            <a:xfrm flipH="1">
              <a:off x="4724280" y="2862360"/>
              <a:ext cx="379080" cy="26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2440" rIns="82440" tIns="41400" bIns="41400" anchor="t">
              <a:spAutoFit/>
            </a:bodyPr>
            <a:p>
              <a:pPr>
                <a:tabLst>
                  <a:tab algn="l" pos="0"/>
                  <a:tab algn="l" pos="739800"/>
                  <a:tab algn="l" pos="1479600"/>
                  <a:tab algn="l" pos="2219400"/>
                  <a:tab algn="l" pos="2959200"/>
                  <a:tab algn="l" pos="3699000"/>
                  <a:tab algn="l" pos="4438800"/>
                  <a:tab algn="l" pos="5178600"/>
                  <a:tab algn="l" pos="5918040"/>
                  <a:tab algn="l" pos="6657840"/>
                  <a:tab algn="l" pos="7397640"/>
                  <a:tab algn="l" pos="8137440"/>
                  <a:tab algn="l" pos="8877240"/>
                  <a:tab algn="l" pos="9617040"/>
                  <a:tab algn="l" pos="1035684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" name="Group 10"/>
          <p:cNvGrpSpPr/>
          <p:nvPr/>
        </p:nvGrpSpPr>
        <p:grpSpPr>
          <a:xfrm>
            <a:off x="4703760" y="2949120"/>
            <a:ext cx="33120" cy="2967480"/>
            <a:chOff x="4703760" y="2949120"/>
            <a:chExt cx="33120" cy="2967480"/>
          </a:xfrm>
        </p:grpSpPr>
        <p:sp>
          <p:nvSpPr>
            <p:cNvPr id="55" name="Line 11"/>
            <p:cNvSpPr/>
            <p:nvPr/>
          </p:nvSpPr>
          <p:spPr>
            <a:xfrm>
              <a:off x="4711680" y="5916600"/>
              <a:ext cx="25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2"/>
            <p:cNvSpPr/>
            <p:nvPr/>
          </p:nvSpPr>
          <p:spPr>
            <a:xfrm>
              <a:off x="4711680" y="5421240"/>
              <a:ext cx="9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3"/>
            <p:cNvSpPr/>
            <p:nvPr/>
          </p:nvSpPr>
          <p:spPr>
            <a:xfrm>
              <a:off x="4711680" y="4930920"/>
              <a:ext cx="25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4"/>
            <p:cNvSpPr/>
            <p:nvPr/>
          </p:nvSpPr>
          <p:spPr>
            <a:xfrm>
              <a:off x="4711680" y="4434840"/>
              <a:ext cx="9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15"/>
            <p:cNvSpPr/>
            <p:nvPr/>
          </p:nvSpPr>
          <p:spPr>
            <a:xfrm>
              <a:off x="4711680" y="3942000"/>
              <a:ext cx="25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16"/>
            <p:cNvSpPr/>
            <p:nvPr/>
          </p:nvSpPr>
          <p:spPr>
            <a:xfrm>
              <a:off x="4711680" y="3448080"/>
              <a:ext cx="9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17"/>
            <p:cNvSpPr/>
            <p:nvPr/>
          </p:nvSpPr>
          <p:spPr>
            <a:xfrm>
              <a:off x="4711680" y="2952720"/>
              <a:ext cx="25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18"/>
            <p:cNvSpPr/>
            <p:nvPr/>
          </p:nvSpPr>
          <p:spPr>
            <a:xfrm flipV="1">
              <a:off x="4703760" y="2949120"/>
              <a:ext cx="0" cy="2962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" name="Rectangle 21"/>
          <p:cNvSpPr/>
          <p:nvPr/>
        </p:nvSpPr>
        <p:spPr>
          <a:xfrm>
            <a:off x="1642320" y="5781600"/>
            <a:ext cx="2509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440" rIns="82440" tIns="41400" bIns="41400" anchor="t">
            <a:spAutoFit/>
          </a:bodyPr>
          <a:p>
            <a:pPr>
              <a:tabLst>
                <a:tab algn="l" pos="0"/>
                <a:tab algn="l" pos="739800"/>
                <a:tab algn="l" pos="1479600"/>
                <a:tab algn="l" pos="2219400"/>
                <a:tab algn="l" pos="2959200"/>
                <a:tab algn="l" pos="3699000"/>
                <a:tab algn="l" pos="4438800"/>
                <a:tab algn="l" pos="5178600"/>
                <a:tab algn="l" pos="5918040"/>
                <a:tab algn="l" pos="6657840"/>
                <a:tab algn="l" pos="7397640"/>
                <a:tab algn="l" pos="8137440"/>
                <a:tab algn="l" pos="8877240"/>
                <a:tab algn="l" pos="9617040"/>
                <a:tab algn="l" pos="1035684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22"/>
          <p:cNvSpPr/>
          <p:nvPr/>
        </p:nvSpPr>
        <p:spPr>
          <a:xfrm>
            <a:off x="1642320" y="5288040"/>
            <a:ext cx="2509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440" rIns="82440" tIns="41400" bIns="41400" anchor="t">
            <a:spAutoFit/>
          </a:bodyPr>
          <a:p>
            <a:pPr>
              <a:tabLst>
                <a:tab algn="l" pos="0"/>
                <a:tab algn="l" pos="739800"/>
                <a:tab algn="l" pos="1479600"/>
                <a:tab algn="l" pos="2219400"/>
                <a:tab algn="l" pos="2959200"/>
                <a:tab algn="l" pos="3699000"/>
                <a:tab algn="l" pos="4438800"/>
                <a:tab algn="l" pos="5178600"/>
                <a:tab algn="l" pos="5918040"/>
                <a:tab algn="l" pos="6657840"/>
                <a:tab algn="l" pos="7397640"/>
                <a:tab algn="l" pos="8137440"/>
                <a:tab algn="l" pos="8877240"/>
                <a:tab algn="l" pos="9617040"/>
                <a:tab algn="l" pos="1035684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23"/>
          <p:cNvSpPr/>
          <p:nvPr/>
        </p:nvSpPr>
        <p:spPr>
          <a:xfrm>
            <a:off x="1642320" y="4792680"/>
            <a:ext cx="2509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440" rIns="82440" tIns="41400" bIns="41400" anchor="t">
            <a:spAutoFit/>
          </a:bodyPr>
          <a:p>
            <a:pPr>
              <a:tabLst>
                <a:tab algn="l" pos="0"/>
                <a:tab algn="l" pos="739800"/>
                <a:tab algn="l" pos="1479600"/>
                <a:tab algn="l" pos="2219400"/>
                <a:tab algn="l" pos="2959200"/>
                <a:tab algn="l" pos="3699000"/>
                <a:tab algn="l" pos="4438800"/>
                <a:tab algn="l" pos="5178600"/>
                <a:tab algn="l" pos="5918040"/>
                <a:tab algn="l" pos="6657840"/>
                <a:tab algn="l" pos="7397640"/>
                <a:tab algn="l" pos="8137440"/>
                <a:tab algn="l" pos="8877240"/>
                <a:tab algn="l" pos="9617040"/>
                <a:tab algn="l" pos="1035684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24"/>
          <p:cNvSpPr/>
          <p:nvPr/>
        </p:nvSpPr>
        <p:spPr>
          <a:xfrm>
            <a:off x="1642320" y="4302000"/>
            <a:ext cx="2509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440" rIns="82440" tIns="41400" bIns="41400" anchor="t">
            <a:spAutoFit/>
          </a:bodyPr>
          <a:p>
            <a:pPr>
              <a:tabLst>
                <a:tab algn="l" pos="0"/>
                <a:tab algn="l" pos="739800"/>
                <a:tab algn="l" pos="1479600"/>
                <a:tab algn="l" pos="2219400"/>
                <a:tab algn="l" pos="2959200"/>
                <a:tab algn="l" pos="3699000"/>
                <a:tab algn="l" pos="4438800"/>
                <a:tab algn="l" pos="5178600"/>
                <a:tab algn="l" pos="5918040"/>
                <a:tab algn="l" pos="6657840"/>
                <a:tab algn="l" pos="7397640"/>
                <a:tab algn="l" pos="8137440"/>
                <a:tab algn="l" pos="8877240"/>
                <a:tab algn="l" pos="9617040"/>
                <a:tab algn="l" pos="1035684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5"/>
          <p:cNvSpPr/>
          <p:nvPr/>
        </p:nvSpPr>
        <p:spPr>
          <a:xfrm>
            <a:off x="1642320" y="3808440"/>
            <a:ext cx="2509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440" rIns="82440" tIns="41400" bIns="41400" anchor="t">
            <a:spAutoFit/>
          </a:bodyPr>
          <a:p>
            <a:pPr>
              <a:tabLst>
                <a:tab algn="l" pos="0"/>
                <a:tab algn="l" pos="739800"/>
                <a:tab algn="l" pos="1479600"/>
                <a:tab algn="l" pos="2219400"/>
                <a:tab algn="l" pos="2959200"/>
                <a:tab algn="l" pos="3699000"/>
                <a:tab algn="l" pos="4438800"/>
                <a:tab algn="l" pos="5178600"/>
                <a:tab algn="l" pos="5918040"/>
                <a:tab algn="l" pos="6657840"/>
                <a:tab algn="l" pos="7397640"/>
                <a:tab algn="l" pos="8137440"/>
                <a:tab algn="l" pos="8877240"/>
                <a:tab algn="l" pos="9617040"/>
                <a:tab algn="l" pos="1035684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26"/>
          <p:cNvSpPr/>
          <p:nvPr/>
        </p:nvSpPr>
        <p:spPr>
          <a:xfrm>
            <a:off x="1596600" y="3314880"/>
            <a:ext cx="33624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440" rIns="82440" tIns="41400" bIns="41400" anchor="t">
            <a:spAutoFit/>
          </a:bodyPr>
          <a:p>
            <a:pPr>
              <a:tabLst>
                <a:tab algn="l" pos="0"/>
                <a:tab algn="l" pos="739800"/>
                <a:tab algn="l" pos="1479600"/>
                <a:tab algn="l" pos="2219400"/>
                <a:tab algn="l" pos="2959200"/>
                <a:tab algn="l" pos="3699000"/>
                <a:tab algn="l" pos="4438800"/>
                <a:tab algn="l" pos="5178600"/>
                <a:tab algn="l" pos="5918040"/>
                <a:tab algn="l" pos="6657840"/>
                <a:tab algn="l" pos="7397640"/>
                <a:tab algn="l" pos="8137440"/>
                <a:tab algn="l" pos="8877240"/>
                <a:tab algn="l" pos="9617040"/>
                <a:tab algn="l" pos="1035684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27"/>
          <p:cNvSpPr/>
          <p:nvPr/>
        </p:nvSpPr>
        <p:spPr>
          <a:xfrm>
            <a:off x="1596600" y="2819520"/>
            <a:ext cx="33624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440" rIns="82440" tIns="41400" bIns="41400" anchor="t">
            <a:spAutoFit/>
          </a:bodyPr>
          <a:p>
            <a:pPr>
              <a:tabLst>
                <a:tab algn="l" pos="0"/>
                <a:tab algn="l" pos="739800"/>
                <a:tab algn="l" pos="1479600"/>
                <a:tab algn="l" pos="2219400"/>
                <a:tab algn="l" pos="2959200"/>
                <a:tab algn="l" pos="3699000"/>
                <a:tab algn="l" pos="4438800"/>
                <a:tab algn="l" pos="5178600"/>
                <a:tab algn="l" pos="5918040"/>
                <a:tab algn="l" pos="6657840"/>
                <a:tab algn="l" pos="7397640"/>
                <a:tab algn="l" pos="8137440"/>
                <a:tab algn="l" pos="8877240"/>
                <a:tab algn="l" pos="9617040"/>
                <a:tab algn="l" pos="1035684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29"/>
          <p:cNvSpPr/>
          <p:nvPr/>
        </p:nvSpPr>
        <p:spPr>
          <a:xfrm flipH="1">
            <a:off x="1875960" y="5916600"/>
            <a:ext cx="34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0"/>
          <p:cNvSpPr/>
          <p:nvPr/>
        </p:nvSpPr>
        <p:spPr>
          <a:xfrm flipH="1">
            <a:off x="1893960" y="5668920"/>
            <a:ext cx="17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1"/>
          <p:cNvSpPr/>
          <p:nvPr/>
        </p:nvSpPr>
        <p:spPr>
          <a:xfrm flipH="1">
            <a:off x="1875960" y="5421240"/>
            <a:ext cx="34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2"/>
          <p:cNvSpPr/>
          <p:nvPr/>
        </p:nvSpPr>
        <p:spPr>
          <a:xfrm flipH="1">
            <a:off x="1893960" y="5175360"/>
            <a:ext cx="17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3"/>
          <p:cNvSpPr/>
          <p:nvPr/>
        </p:nvSpPr>
        <p:spPr>
          <a:xfrm flipH="1">
            <a:off x="1875960" y="4929120"/>
            <a:ext cx="34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4"/>
          <p:cNvSpPr/>
          <p:nvPr/>
        </p:nvSpPr>
        <p:spPr>
          <a:xfrm flipH="1">
            <a:off x="1893960" y="4681440"/>
            <a:ext cx="17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5"/>
          <p:cNvSpPr/>
          <p:nvPr/>
        </p:nvSpPr>
        <p:spPr>
          <a:xfrm flipH="1">
            <a:off x="1875960" y="4435560"/>
            <a:ext cx="34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36"/>
          <p:cNvSpPr/>
          <p:nvPr/>
        </p:nvSpPr>
        <p:spPr>
          <a:xfrm flipH="1">
            <a:off x="1893960" y="4187880"/>
            <a:ext cx="17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37"/>
          <p:cNvSpPr/>
          <p:nvPr/>
        </p:nvSpPr>
        <p:spPr>
          <a:xfrm flipH="1">
            <a:off x="1875960" y="3940200"/>
            <a:ext cx="34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38"/>
          <p:cNvSpPr/>
          <p:nvPr/>
        </p:nvSpPr>
        <p:spPr>
          <a:xfrm flipH="1">
            <a:off x="1893960" y="3693960"/>
            <a:ext cx="17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39"/>
          <p:cNvSpPr/>
          <p:nvPr/>
        </p:nvSpPr>
        <p:spPr>
          <a:xfrm flipH="1">
            <a:off x="1875960" y="3448080"/>
            <a:ext cx="34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0"/>
          <p:cNvSpPr/>
          <p:nvPr/>
        </p:nvSpPr>
        <p:spPr>
          <a:xfrm flipH="1">
            <a:off x="1893960" y="3200400"/>
            <a:ext cx="17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41"/>
          <p:cNvSpPr/>
          <p:nvPr/>
        </p:nvSpPr>
        <p:spPr>
          <a:xfrm flipH="1">
            <a:off x="1875960" y="2954160"/>
            <a:ext cx="34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42"/>
          <p:cNvSpPr/>
          <p:nvPr/>
        </p:nvSpPr>
        <p:spPr>
          <a:xfrm flipV="1">
            <a:off x="1916280" y="2947680"/>
            <a:ext cx="0" cy="2963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44"/>
          <p:cNvSpPr/>
          <p:nvPr/>
        </p:nvSpPr>
        <p:spPr>
          <a:xfrm rot="16200000">
            <a:off x="-231120" y="4257720"/>
            <a:ext cx="3017520" cy="27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C28068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evel at 1 h (% dose/g tumou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45"/>
          <p:cNvSpPr/>
          <p:nvPr/>
        </p:nvSpPr>
        <p:spPr>
          <a:xfrm rot="16200000">
            <a:off x="4577040" y="4297320"/>
            <a:ext cx="1778760" cy="27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ox release rate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%/h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47"/>
          <p:cNvSpPr/>
          <p:nvPr/>
        </p:nvSpPr>
        <p:spPr>
          <a:xfrm>
            <a:off x="1979280" y="5956200"/>
            <a:ext cx="519840" cy="453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5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48"/>
          <p:cNvSpPr/>
          <p:nvPr/>
        </p:nvSpPr>
        <p:spPr>
          <a:xfrm>
            <a:off x="2565000" y="5956200"/>
            <a:ext cx="519840" cy="453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Group 50" descr=""/>
          <p:cNvPicPr/>
          <p:nvPr/>
        </p:nvPicPr>
        <p:blipFill>
          <a:blip r:embed="rId1"/>
          <a:stretch/>
        </p:blipFill>
        <p:spPr>
          <a:xfrm>
            <a:off x="3425760" y="4170240"/>
            <a:ext cx="530280" cy="1760760"/>
          </a:xfrm>
          <a:prstGeom prst="rect">
            <a:avLst/>
          </a:prstGeom>
          <a:ln w="0">
            <a:noFill/>
          </a:ln>
        </p:spPr>
      </p:pic>
      <p:pic>
        <p:nvPicPr>
          <p:cNvPr id="89" name="Group 54" descr=""/>
          <p:cNvPicPr/>
          <p:nvPr/>
        </p:nvPicPr>
        <p:blipFill>
          <a:blip r:embed="rId2"/>
          <a:stretch/>
        </p:blipFill>
        <p:spPr>
          <a:xfrm>
            <a:off x="3925800" y="4900680"/>
            <a:ext cx="530280" cy="1030320"/>
          </a:xfrm>
          <a:prstGeom prst="rect">
            <a:avLst/>
          </a:prstGeom>
          <a:ln w="0">
            <a:noFill/>
          </a:ln>
        </p:spPr>
      </p:pic>
      <p:sp>
        <p:nvSpPr>
          <p:cNvPr id="90" name="Rectangle 58"/>
          <p:cNvSpPr/>
          <p:nvPr/>
        </p:nvSpPr>
        <p:spPr>
          <a:xfrm>
            <a:off x="4077720" y="4665600"/>
            <a:ext cx="240840" cy="27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Group 60" descr=""/>
          <p:cNvPicPr/>
          <p:nvPr/>
        </p:nvPicPr>
        <p:blipFill>
          <a:blip r:embed="rId3"/>
          <a:stretch/>
        </p:blipFill>
        <p:spPr>
          <a:xfrm>
            <a:off x="2011320" y="3371760"/>
            <a:ext cx="536760" cy="2559240"/>
          </a:xfrm>
          <a:prstGeom prst="rect">
            <a:avLst/>
          </a:prstGeom>
          <a:ln w="0">
            <a:noFill/>
          </a:ln>
        </p:spPr>
      </p:pic>
      <p:pic>
        <p:nvPicPr>
          <p:cNvPr id="92" name="Group 64" descr=""/>
          <p:cNvPicPr/>
          <p:nvPr/>
        </p:nvPicPr>
        <p:blipFill>
          <a:blip r:embed="rId4"/>
          <a:stretch/>
        </p:blipFill>
        <p:spPr>
          <a:xfrm>
            <a:off x="2523960" y="3438360"/>
            <a:ext cx="536760" cy="2492640"/>
          </a:xfrm>
          <a:prstGeom prst="rect">
            <a:avLst/>
          </a:prstGeom>
          <a:ln w="0">
            <a:noFill/>
          </a:ln>
        </p:spPr>
      </p:pic>
      <p:sp>
        <p:nvSpPr>
          <p:cNvPr id="93" name="Rectangle 68"/>
          <p:cNvSpPr/>
          <p:nvPr/>
        </p:nvSpPr>
        <p:spPr>
          <a:xfrm>
            <a:off x="2652120" y="3176640"/>
            <a:ext cx="428400" cy="27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.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70"/>
          <p:cNvSpPr/>
          <p:nvPr/>
        </p:nvSpPr>
        <p:spPr>
          <a:xfrm>
            <a:off x="3416040" y="5956200"/>
            <a:ext cx="519840" cy="453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5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71"/>
          <p:cNvSpPr/>
          <p:nvPr/>
        </p:nvSpPr>
        <p:spPr>
          <a:xfrm>
            <a:off x="4001760" y="5956200"/>
            <a:ext cx="519840" cy="453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77"/>
          <p:cNvSpPr/>
          <p:nvPr/>
        </p:nvSpPr>
        <p:spPr>
          <a:xfrm>
            <a:off x="1773360" y="6553080"/>
            <a:ext cx="423720" cy="233640"/>
          </a:xfrm>
          <a:prstGeom prst="rect">
            <a:avLst/>
          </a:prstGeom>
          <a:solidFill>
            <a:srgbClr val="00009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78"/>
          <p:cNvSpPr/>
          <p:nvPr/>
        </p:nvSpPr>
        <p:spPr>
          <a:xfrm>
            <a:off x="2227320" y="6553080"/>
            <a:ext cx="423720" cy="233640"/>
          </a:xfrm>
          <a:prstGeom prst="rect">
            <a:avLst/>
          </a:prstGeom>
          <a:solidFill>
            <a:srgbClr val="008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80"/>
          <p:cNvSpPr/>
          <p:nvPr/>
        </p:nvSpPr>
        <p:spPr>
          <a:xfrm>
            <a:off x="1773360" y="6931080"/>
            <a:ext cx="423720" cy="23328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81"/>
          <p:cNvSpPr/>
          <p:nvPr/>
        </p:nvSpPr>
        <p:spPr>
          <a:xfrm>
            <a:off x="2227320" y="6931080"/>
            <a:ext cx="423720" cy="23328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84"/>
          <p:cNvSpPr/>
          <p:nvPr/>
        </p:nvSpPr>
        <p:spPr>
          <a:xfrm>
            <a:off x="1927080" y="5931000"/>
            <a:ext cx="2819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85"/>
          <p:cNvSpPr/>
          <p:nvPr/>
        </p:nvSpPr>
        <p:spPr>
          <a:xfrm>
            <a:off x="3427560" y="3124080"/>
            <a:ext cx="109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*   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&lt; 0.05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86"/>
          <p:cNvSpPr/>
          <p:nvPr/>
        </p:nvSpPr>
        <p:spPr>
          <a:xfrm>
            <a:off x="2852640" y="6588000"/>
            <a:ext cx="126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otal PK1 lev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87"/>
          <p:cNvSpPr/>
          <p:nvPr/>
        </p:nvSpPr>
        <p:spPr>
          <a:xfrm>
            <a:off x="2859480" y="6888240"/>
            <a:ext cx="164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ate of DOX rele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8T17:33:08Z</dcterms:created>
  <dc:creator>UMMS User</dc:creator>
  <dc:description/>
  <dc:language>en-US</dc:language>
  <cp:lastModifiedBy>0002486</cp:lastModifiedBy>
  <dcterms:modified xsi:type="dcterms:W3CDTF">2013-06-01T14:26:07Z</dcterms:modified>
  <cp:revision>3</cp:revision>
  <dc:subject/>
  <dc:title>Slide 1</dc:title>
</cp:coreProperties>
</file>